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44" autoAdjust="0"/>
    <p:restoredTop sz="86496"/>
  </p:normalViewPr>
  <p:slideViewPr>
    <p:cSldViewPr snapToGrid="0">
      <p:cViewPr varScale="1">
        <p:scale>
          <a:sx n="80" d="100"/>
          <a:sy n="80" d="100"/>
        </p:scale>
        <p:origin x="848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9D63DB-BB31-A541-932F-CA4E52AC02FD}" type="datetimeFigureOut">
              <a:rPr kumimoji="1" lang="zh-TW" altLang="en-US" smtClean="0"/>
              <a:t>2022/4/29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F53E50-48C1-E444-82FD-893066393AFE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7262438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F53E50-48C1-E444-82FD-893066393AFE}" type="slidenum">
              <a:rPr kumimoji="1" lang="zh-TW" altLang="en-US" smtClean="0"/>
              <a:t>1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629694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9ADD321-EF9A-4617-85E9-DD46C47A7E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7F4637F8-2928-4F77-AAB5-D3B2CC0565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D1581B0-9BF9-499B-872B-D90228102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53DEF17-F6F0-472D-A4A2-939DCBCC0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968A833-56C2-4DBB-BE7C-74C0F3115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9988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299C7DE-C791-44DC-9245-307494C3A9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4DF80C55-6979-495E-886F-29A404A31A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54E90C1-267B-4F94-8D98-2F70F8A0F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A1B5D55-9737-49F1-B75A-4D71C5A76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9D16C21-5B70-4542-9E49-C8E33479C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71175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0857252C-DA2E-4CE8-BD85-E91B9AE876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97F36362-55CA-42EB-ADF6-212DB132AB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5877AF0-706B-4366-848D-9CBCD8945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325DEE6-CBEB-4F24-9440-782BE3DBD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EF425CE-A698-47E2-BF0D-D3CFE2CBF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0220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FCF52DD-BDAA-463A-9C33-6975C35D5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99A7093-E4B7-426A-9822-C3E01AE98C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5CC393A-848B-45BA-B08B-EA7BCA9DA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62D5F25-B290-42A8-BBAE-B2EFBA3B4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16B7368-FD4B-4749-BF77-896A57188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5766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DD4E354-ED3C-4896-B4CD-14B8D78BB6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8E8480A8-1DAE-4D90-8FC1-C28A4C6F50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70C197E-736E-4985-A293-3DFC26F6C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4C627C2-4A40-4CA0-B89B-81851B9E86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E4D47FD-62D4-4206-AFB6-9BE045B97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37070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EC3F0F4-CAAB-4B82-80DB-A2FD981175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30B7C651-7867-4A7A-ACAC-547706E60C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4D68CCC-2470-4710-9C1F-AD5EE562E0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9488BF8-EDDB-4484-AD19-4D9C232D7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A451F34-393D-4B83-A696-E36E7E567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CD78D97-BA87-46C1-87AD-2D6B95BDB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38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476000C-A592-41A9-BC7B-85604A36D3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862D2B3-F6E3-498F-8587-6864A4541D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5D4B0901-FDD0-4B1D-823E-96C66A8464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02634D75-649E-4303-B444-CAEB039A1F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8BF861BC-7478-4C7F-B6FF-BC7565B51E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E1F3895F-3246-416C-8595-33523CE7D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4DEBC873-3057-4767-972B-5CED6ADF8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95A54413-B582-4D57-9A07-3457ECEA8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705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5CD789D-661A-4F65-94E0-94C8921B0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7C3FB961-72BB-4534-8FF1-776CEB3FE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8977C969-064A-4A1B-AAC9-94C2864C1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01F8CF2E-C35A-4249-A890-7C7E33534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5126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EA7C5BCE-FE18-4A4F-88D9-66A7BC0D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93FBE782-CF91-4405-91D1-DEAB6BF5B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3EA66568-C0FE-46A8-BE2F-EAD09F4C8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3559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0EA195C-5B80-4D7D-B247-D048C846D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44E46D0E-8F92-4AAB-AF5B-CD19401C8C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5ABF883E-F524-482C-AE25-802522A61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7322391-4DD4-40CC-9032-A386C20A6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84B43D5-43D7-4CC9-A21A-28A543972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1AE2174-FBB1-41DD-A97B-9CA43E6CF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13402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2453C9-0638-42B8-BB49-A810E1711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A2668180-A48B-4C9C-B551-9A76586C6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961F8D08-8DBB-45CF-8146-FCD49462DD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D13958B5-43CE-4A94-AEB1-FE63278C2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14014C8F-DDEE-4881-9225-68872A0F3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D1CFE1D2-BF9E-41BA-8A28-7B922F4E6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90754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E99782B2-3E3C-45CA-A589-8448DF195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E8C088C-EF33-4051-90F1-7CE3705CC8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BD91206-FC10-4D95-B4AF-2F8B6E325E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56E793E-D142-4294-B01E-5FF6845780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16867BE-2393-4F8E-B189-7793B36209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77693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189A8ED4-64F4-CE4B-8ECC-8817C1F153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064418"/>
            <a:ext cx="4714875" cy="3536156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68D22650-47B5-1B48-94B2-404C2B57EB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8800" y="1046559"/>
            <a:ext cx="4738686" cy="3554015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EC68254E-808B-6F46-9281-0AE10DAB6BA4}"/>
              </a:ext>
            </a:extLst>
          </p:cNvPr>
          <p:cNvSpPr/>
          <p:nvPr/>
        </p:nvSpPr>
        <p:spPr>
          <a:xfrm>
            <a:off x="685800" y="4826675"/>
            <a:ext cx="1025842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TW" dirty="0"/>
              <a:t>Supplementary Figure 2. </a:t>
            </a:r>
            <a:r>
              <a:rPr lang="en-US" altLang="zh-TW" b="1" dirty="0"/>
              <a:t>Detection of the expression of STAT3 (A) and phospho-STAT3 (B) by immunocytochemistry in primary feline normal soft tissue cells. </a:t>
            </a:r>
            <a:r>
              <a:rPr lang="en-US" altLang="zh-TW" dirty="0"/>
              <a:t>The antibody specifically targeting STAT 3 and phospho-STAT3 (Tyr705) was applied to the cells, detected by </a:t>
            </a:r>
            <a:r>
              <a:rPr lang="en-US" altLang="zh-TW" dirty="0" err="1"/>
              <a:t>Dako</a:t>
            </a:r>
            <a:r>
              <a:rPr lang="en-US" altLang="zh-TW" dirty="0"/>
              <a:t> Real Envision-HRP (rabbit/mouse) (</a:t>
            </a:r>
            <a:r>
              <a:rPr lang="en-US" altLang="zh-TW" dirty="0" err="1"/>
              <a:t>Dako</a:t>
            </a:r>
            <a:r>
              <a:rPr lang="en-US" altLang="zh-TW" dirty="0"/>
              <a:t> Denmark A/S, </a:t>
            </a:r>
            <a:r>
              <a:rPr lang="en-US" altLang="zh-TW" dirty="0" err="1"/>
              <a:t>Glostrup</a:t>
            </a:r>
            <a:r>
              <a:rPr lang="en-US" altLang="zh-TW" dirty="0"/>
              <a:t>, Denmark), visualized with 2% diaminobenzidine (Real DAB+ chromogen, </a:t>
            </a:r>
            <a:r>
              <a:rPr lang="en-US" altLang="zh-TW" dirty="0" err="1"/>
              <a:t>Dako</a:t>
            </a:r>
            <a:r>
              <a:rPr lang="en-US" altLang="zh-TW" dirty="0"/>
              <a:t> Denmark A/S, </a:t>
            </a:r>
            <a:r>
              <a:rPr lang="en-US" altLang="zh-TW" dirty="0" err="1"/>
              <a:t>Glostrup</a:t>
            </a:r>
            <a:r>
              <a:rPr lang="en-US" altLang="zh-TW" dirty="0"/>
              <a:t>, Denmark), and  counterstained with hematoxylin (Muto Pure Chemicals, Tokyo, Japan).</a:t>
            </a:r>
            <a:endParaRPr lang="zh-TW" altLang="zh-TW" dirty="0"/>
          </a:p>
          <a:p>
            <a:endParaRPr lang="zh-TW" altLang="zh-TW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70E79E19-69FD-F049-B10F-1336E64029BD}"/>
              </a:ext>
            </a:extLst>
          </p:cNvPr>
          <p:cNvSpPr txBox="1"/>
          <p:nvPr/>
        </p:nvSpPr>
        <p:spPr>
          <a:xfrm>
            <a:off x="685800" y="10465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dirty="0"/>
              <a:t>A</a:t>
            </a:r>
            <a:endParaRPr kumimoji="1" lang="zh-TW" altLang="en-US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527BD0DF-5CB3-CA4F-8AC9-C5A6FD862AA8}"/>
              </a:ext>
            </a:extLst>
          </p:cNvPr>
          <p:cNvSpPr txBox="1"/>
          <p:nvPr/>
        </p:nvSpPr>
        <p:spPr>
          <a:xfrm>
            <a:off x="5767388" y="104655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dirty="0"/>
              <a:t>B</a:t>
            </a:r>
            <a:endParaRPr kumimoji="1"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042785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103</Words>
  <Application>Microsoft Macintosh PowerPoint</Application>
  <PresentationFormat>寬螢幕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小心 施</dc:creator>
  <cp:lastModifiedBy>Microsoft Office 使用者</cp:lastModifiedBy>
  <cp:revision>17</cp:revision>
  <dcterms:created xsi:type="dcterms:W3CDTF">2022-01-10T23:56:50Z</dcterms:created>
  <dcterms:modified xsi:type="dcterms:W3CDTF">2022-04-29T06:25:12Z</dcterms:modified>
</cp:coreProperties>
</file>